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4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y%20Drive\JJD%20Lab%202022\Projects\Research\In%20Press%20or%20Published\HDAC6%20Manuscript\Experiments\HDAC6%20Rebuttal\HLA-ABC%20MMCL\DATA%20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y%20Drive\JJD%20Lab%202022\Projects\Research\In%20Press%20or%20Published\HDAC6%20Manuscript\Experiments\HDAC6%20Rebuttal\E.G7-Ova\SIINFEKL%20compil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RPMI-8226</c:v>
          </c:tx>
          <c:spPr>
            <a:solidFill>
              <a:srgbClr val="FF33CC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ompilation!$C$2:$C$6</c:f>
                <c:numCache>
                  <c:formatCode>General</c:formatCode>
                  <c:ptCount val="5"/>
                  <c:pt idx="0">
                    <c:v>5.5328466770478766</c:v>
                  </c:pt>
                  <c:pt idx="1">
                    <c:v>10.074927219372636</c:v>
                  </c:pt>
                  <c:pt idx="2">
                    <c:v>9.7318609608344051</c:v>
                  </c:pt>
                  <c:pt idx="3">
                    <c:v>10.298008208830105</c:v>
                  </c:pt>
                  <c:pt idx="4">
                    <c:v>4.6665350497401059</c:v>
                  </c:pt>
                </c:numCache>
              </c:numRef>
            </c:plus>
            <c:minus>
              <c:numRef>
                <c:f>Compilation!$C$2:$C$6</c:f>
                <c:numCache>
                  <c:formatCode>General</c:formatCode>
                  <c:ptCount val="5"/>
                  <c:pt idx="0">
                    <c:v>5.5328466770478766</c:v>
                  </c:pt>
                  <c:pt idx="1">
                    <c:v>10.074927219372636</c:v>
                  </c:pt>
                  <c:pt idx="2">
                    <c:v>9.7318609608344051</c:v>
                  </c:pt>
                  <c:pt idx="3">
                    <c:v>10.298008208830105</c:v>
                  </c:pt>
                  <c:pt idx="4">
                    <c:v>4.6665350497401059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Compilation!$A$2:$A$6</c:f>
              <c:numCache>
                <c:formatCode>General</c:formatCode>
                <c:ptCount val="5"/>
                <c:pt idx="0">
                  <c:v>0</c:v>
                </c:pt>
                <c:pt idx="1">
                  <c:v>0.3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</c:numCache>
            </c:numRef>
          </c:cat>
          <c:val>
            <c:numRef>
              <c:f>Compilation!$B$2:$B$6</c:f>
              <c:numCache>
                <c:formatCode>General</c:formatCode>
                <c:ptCount val="5"/>
                <c:pt idx="0">
                  <c:v>100</c:v>
                </c:pt>
                <c:pt idx="1">
                  <c:v>101.73732479667763</c:v>
                </c:pt>
                <c:pt idx="2">
                  <c:v>102.63021283959164</c:v>
                </c:pt>
                <c:pt idx="3">
                  <c:v>104.68593182211457</c:v>
                </c:pt>
                <c:pt idx="4">
                  <c:v>106.869700640249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D7-46F9-8642-8DB42BA6E669}"/>
            </c:ext>
          </c:extLst>
        </c:ser>
        <c:ser>
          <c:idx val="1"/>
          <c:order val="1"/>
          <c:tx>
            <c:v>ARH77</c:v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ompilation!$E$2:$E$6</c:f>
                <c:numCache>
                  <c:formatCode>General</c:formatCode>
                  <c:ptCount val="5"/>
                  <c:pt idx="0">
                    <c:v>13.537313118588136</c:v>
                  </c:pt>
                  <c:pt idx="1">
                    <c:v>11.253243500124034</c:v>
                  </c:pt>
                  <c:pt idx="2">
                    <c:v>10.856048012828165</c:v>
                  </c:pt>
                  <c:pt idx="3">
                    <c:v>8.4558763401612751</c:v>
                  </c:pt>
                  <c:pt idx="4">
                    <c:v>5.8598946858574443</c:v>
                  </c:pt>
                </c:numCache>
              </c:numRef>
            </c:plus>
            <c:minus>
              <c:numRef>
                <c:f>Compilation!$E$2:$E$6</c:f>
                <c:numCache>
                  <c:formatCode>General</c:formatCode>
                  <c:ptCount val="5"/>
                  <c:pt idx="0">
                    <c:v>13.537313118588136</c:v>
                  </c:pt>
                  <c:pt idx="1">
                    <c:v>11.253243500124034</c:v>
                  </c:pt>
                  <c:pt idx="2">
                    <c:v>10.856048012828165</c:v>
                  </c:pt>
                  <c:pt idx="3">
                    <c:v>8.4558763401612751</c:v>
                  </c:pt>
                  <c:pt idx="4">
                    <c:v>5.8598946858574443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Compilation!$D$2:$D$6</c:f>
              <c:numCache>
                <c:formatCode>General</c:formatCode>
                <c:ptCount val="5"/>
                <c:pt idx="0">
                  <c:v>100</c:v>
                </c:pt>
                <c:pt idx="1">
                  <c:v>101.90936148705565</c:v>
                </c:pt>
                <c:pt idx="2">
                  <c:v>106.54237097770537</c:v>
                </c:pt>
                <c:pt idx="3">
                  <c:v>93.92935362497893</c:v>
                </c:pt>
                <c:pt idx="4">
                  <c:v>99.606896164429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D7-46F9-8642-8DB42BA6E669}"/>
            </c:ext>
          </c:extLst>
        </c:ser>
        <c:ser>
          <c:idx val="2"/>
          <c:order val="2"/>
          <c:tx>
            <c:v>U266</c:v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ompilation!$G$2:$G$6</c:f>
                <c:numCache>
                  <c:formatCode>General</c:formatCode>
                  <c:ptCount val="5"/>
                  <c:pt idx="0">
                    <c:v>9.2029225151590577</c:v>
                  </c:pt>
                  <c:pt idx="1">
                    <c:v>6.6363465386409999</c:v>
                  </c:pt>
                  <c:pt idx="2">
                    <c:v>9.288757214157668</c:v>
                  </c:pt>
                  <c:pt idx="3">
                    <c:v>9.4160185216663006</c:v>
                  </c:pt>
                  <c:pt idx="4">
                    <c:v>8.7223788829834277</c:v>
                  </c:pt>
                </c:numCache>
              </c:numRef>
            </c:plus>
            <c:minus>
              <c:numRef>
                <c:f>Compilation!$G$2:$G$6</c:f>
                <c:numCache>
                  <c:formatCode>General</c:formatCode>
                  <c:ptCount val="5"/>
                  <c:pt idx="0">
                    <c:v>9.2029225151590577</c:v>
                  </c:pt>
                  <c:pt idx="1">
                    <c:v>6.6363465386409999</c:v>
                  </c:pt>
                  <c:pt idx="2">
                    <c:v>9.288757214157668</c:v>
                  </c:pt>
                  <c:pt idx="3">
                    <c:v>9.4160185216663006</c:v>
                  </c:pt>
                  <c:pt idx="4">
                    <c:v>8.7223788829834277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Compilation!$F$2:$F$6</c:f>
              <c:numCache>
                <c:formatCode>General</c:formatCode>
                <c:ptCount val="5"/>
                <c:pt idx="0">
                  <c:v>100</c:v>
                </c:pt>
                <c:pt idx="1">
                  <c:v>101.98513592802661</c:v>
                </c:pt>
                <c:pt idx="2">
                  <c:v>100.22491687854489</c:v>
                </c:pt>
                <c:pt idx="3">
                  <c:v>96.029728143946812</c:v>
                </c:pt>
                <c:pt idx="4">
                  <c:v>101.007236456092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8D7-46F9-8642-8DB42BA6E6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6194351"/>
        <c:axId val="115609727"/>
      </c:barChart>
      <c:catAx>
        <c:axId val="226194351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5609727"/>
        <c:crosses val="autoZero"/>
        <c:auto val="1"/>
        <c:lblAlgn val="ctr"/>
        <c:lblOffset val="100"/>
        <c:noMultiLvlLbl val="0"/>
      </c:catAx>
      <c:valAx>
        <c:axId val="115609727"/>
        <c:scaling>
          <c:orientation val="minMax"/>
          <c:max val="12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61943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E.G7-Ova</c:v>
          </c:tx>
          <c:spPr>
            <a:solidFill>
              <a:srgbClr val="9999FF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3B9-470D-A613-E44FC0360F5E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C$2:$C$6</c:f>
                <c:numCache>
                  <c:formatCode>General</c:formatCode>
                  <c:ptCount val="5"/>
                  <c:pt idx="0">
                    <c:v>3.6309746174589148</c:v>
                  </c:pt>
                  <c:pt idx="1">
                    <c:v>2.5240197735277863</c:v>
                  </c:pt>
                  <c:pt idx="2">
                    <c:v>3.3012873254550037</c:v>
                  </c:pt>
                  <c:pt idx="3">
                    <c:v>6.2302206850449684</c:v>
                  </c:pt>
                  <c:pt idx="4">
                    <c:v>5.6088600865542908</c:v>
                  </c:pt>
                </c:numCache>
              </c:numRef>
            </c:plus>
            <c:minus>
              <c:numRef>
                <c:f>Sheet2!$C$2:$C$6</c:f>
                <c:numCache>
                  <c:formatCode>General</c:formatCode>
                  <c:ptCount val="5"/>
                  <c:pt idx="0">
                    <c:v>3.6309746174589148</c:v>
                  </c:pt>
                  <c:pt idx="1">
                    <c:v>2.5240197735277863</c:v>
                  </c:pt>
                  <c:pt idx="2">
                    <c:v>3.3012873254550037</c:v>
                  </c:pt>
                  <c:pt idx="3">
                    <c:v>6.2302206850449684</c:v>
                  </c:pt>
                  <c:pt idx="4">
                    <c:v>5.6088600865542908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A$2:$A$6</c:f>
              <c:numCache>
                <c:formatCode>General</c:formatCode>
                <c:ptCount val="5"/>
                <c:pt idx="0">
                  <c:v>0</c:v>
                </c:pt>
                <c:pt idx="1">
                  <c:v>0.3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</c:numCache>
            </c:numRef>
          </c:cat>
          <c:val>
            <c:numRef>
              <c:f>Sheet2!$B$2:$B$6</c:f>
              <c:numCache>
                <c:formatCode>General</c:formatCode>
                <c:ptCount val="5"/>
                <c:pt idx="0">
                  <c:v>100</c:v>
                </c:pt>
                <c:pt idx="1">
                  <c:v>104.68331616889806</c:v>
                </c:pt>
                <c:pt idx="2">
                  <c:v>98.833676622039135</c:v>
                </c:pt>
                <c:pt idx="3">
                  <c:v>96.145726055612769</c:v>
                </c:pt>
                <c:pt idx="4">
                  <c:v>100.659114315139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B9-470D-A613-E44FC0360F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26194351"/>
        <c:axId val="115609727"/>
      </c:barChart>
      <c:catAx>
        <c:axId val="226194351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5609727"/>
        <c:crosses val="autoZero"/>
        <c:auto val="1"/>
        <c:lblAlgn val="ctr"/>
        <c:lblOffset val="100"/>
        <c:noMultiLvlLbl val="0"/>
      </c:catAx>
      <c:valAx>
        <c:axId val="115609727"/>
        <c:scaling>
          <c:orientation val="minMax"/>
          <c:max val="12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61943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5"/>
          <p:cNvSpPr txBox="1"/>
          <p:nvPr/>
        </p:nvSpPr>
        <p:spPr>
          <a:xfrm>
            <a:off x="912430" y="354243"/>
            <a:ext cx="9603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S11</a:t>
            </a:r>
            <a:endParaRPr 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5426029A-79E4-987D-8834-B33C98425E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5668551"/>
              </p:ext>
            </p:extLst>
          </p:nvPr>
        </p:nvGraphicFramePr>
        <p:xfrm>
          <a:off x="5787186" y="1479883"/>
          <a:ext cx="433917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E390EF17-D05B-49C9-B862-1D5940A614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9104769"/>
              </p:ext>
            </p:extLst>
          </p:nvPr>
        </p:nvGraphicFramePr>
        <p:xfrm>
          <a:off x="1399172" y="1479884"/>
          <a:ext cx="24955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193B190-21FA-8CCD-1C39-3FDBC00D33D4}"/>
              </a:ext>
            </a:extLst>
          </p:cNvPr>
          <p:cNvSpPr txBox="1"/>
          <p:nvPr/>
        </p:nvSpPr>
        <p:spPr>
          <a:xfrm>
            <a:off x="2106946" y="4159471"/>
            <a:ext cx="161889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SGC-UBD253N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26C7612-1BF1-F76C-5B38-74D78D9E4067}"/>
              </a:ext>
            </a:extLst>
          </p:cNvPr>
          <p:cNvSpPr txBox="1"/>
          <p:nvPr/>
        </p:nvSpPr>
        <p:spPr>
          <a:xfrm rot="16200000">
            <a:off x="171987" y="2720678"/>
            <a:ext cx="21796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INFEKL-H2Kb, Relative %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8017129-8CEA-C20F-02E5-3EC7BBCEB192}"/>
              </a:ext>
            </a:extLst>
          </p:cNvPr>
          <p:cNvSpPr txBox="1"/>
          <p:nvPr/>
        </p:nvSpPr>
        <p:spPr>
          <a:xfrm rot="16200000">
            <a:off x="4739103" y="2651323"/>
            <a:ext cx="1828799" cy="267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n HLA-ABC, relative %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56DF843-6FE5-0515-D337-698A0CB458E9}"/>
              </a:ext>
            </a:extLst>
          </p:cNvPr>
          <p:cNvSpPr txBox="1"/>
          <p:nvPr/>
        </p:nvSpPr>
        <p:spPr>
          <a:xfrm>
            <a:off x="7526509" y="4178153"/>
            <a:ext cx="161889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SGC-UBD253N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8071342-4E8B-2023-9735-C5B8BCF1AF84}"/>
              </a:ext>
            </a:extLst>
          </p:cNvPr>
          <p:cNvSpPr/>
          <p:nvPr/>
        </p:nvSpPr>
        <p:spPr>
          <a:xfrm>
            <a:off x="10126362" y="1599123"/>
            <a:ext cx="164592" cy="164592"/>
          </a:xfrm>
          <a:prstGeom prst="rect">
            <a:avLst/>
          </a:prstGeom>
          <a:solidFill>
            <a:srgbClr val="00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6B2DD04-FC2A-A98B-1B72-E8C4A96735C6}"/>
              </a:ext>
            </a:extLst>
          </p:cNvPr>
          <p:cNvSpPr/>
          <p:nvPr/>
        </p:nvSpPr>
        <p:spPr>
          <a:xfrm>
            <a:off x="10128900" y="1351315"/>
            <a:ext cx="164592" cy="163653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87BA453-68D4-9BC8-143A-E023A70E7A85}"/>
              </a:ext>
            </a:extLst>
          </p:cNvPr>
          <p:cNvSpPr/>
          <p:nvPr/>
        </p:nvSpPr>
        <p:spPr>
          <a:xfrm>
            <a:off x="10127913" y="1098611"/>
            <a:ext cx="164592" cy="164592"/>
          </a:xfrm>
          <a:prstGeom prst="rect">
            <a:avLst/>
          </a:prstGeom>
          <a:solidFill>
            <a:srgbClr val="FF33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7006D34-7F2A-48FE-4283-BED0167ADE8E}"/>
              </a:ext>
            </a:extLst>
          </p:cNvPr>
          <p:cNvSpPr/>
          <p:nvPr/>
        </p:nvSpPr>
        <p:spPr>
          <a:xfrm>
            <a:off x="3413708" y="1199591"/>
            <a:ext cx="164592" cy="164592"/>
          </a:xfrm>
          <a:prstGeom prst="rect">
            <a:avLst/>
          </a:prstGeom>
          <a:solidFill>
            <a:srgbClr val="99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9D2F8A2-3E2C-B741-2AFA-B064E4D93358}"/>
              </a:ext>
            </a:extLst>
          </p:cNvPr>
          <p:cNvSpPr txBox="1"/>
          <p:nvPr/>
        </p:nvSpPr>
        <p:spPr>
          <a:xfrm>
            <a:off x="3578300" y="1151082"/>
            <a:ext cx="161889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.G7-Ov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5D7357D-A493-C6E9-27DD-C4EB5DC9FDA0}"/>
              </a:ext>
            </a:extLst>
          </p:cNvPr>
          <p:cNvSpPr txBox="1"/>
          <p:nvPr/>
        </p:nvSpPr>
        <p:spPr>
          <a:xfrm>
            <a:off x="10401790" y="1050102"/>
            <a:ext cx="161889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PMI-822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74E02E1-4857-1BC5-08D0-7421364155EB}"/>
              </a:ext>
            </a:extLst>
          </p:cNvPr>
          <p:cNvSpPr txBox="1"/>
          <p:nvPr/>
        </p:nvSpPr>
        <p:spPr>
          <a:xfrm>
            <a:off x="10401790" y="1307069"/>
            <a:ext cx="161889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RH7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E839793-5AC8-9203-979E-6B3F8EB442FD}"/>
              </a:ext>
            </a:extLst>
          </p:cNvPr>
          <p:cNvSpPr txBox="1"/>
          <p:nvPr/>
        </p:nvSpPr>
        <p:spPr>
          <a:xfrm>
            <a:off x="10401790" y="1564036"/>
            <a:ext cx="161889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26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FFDB3A0-F4B2-6B6F-8D1E-20CB9E205177}"/>
              </a:ext>
            </a:extLst>
          </p:cNvPr>
          <p:cNvSpPr txBox="1"/>
          <p:nvPr/>
        </p:nvSpPr>
        <p:spPr>
          <a:xfrm>
            <a:off x="960391" y="66684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179CC31-A2E5-FC90-C380-3F84B12953BC}"/>
              </a:ext>
            </a:extLst>
          </p:cNvPr>
          <p:cNvSpPr txBox="1"/>
          <p:nvPr/>
        </p:nvSpPr>
        <p:spPr>
          <a:xfrm>
            <a:off x="5787186" y="666840"/>
            <a:ext cx="325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912430" y="4475407"/>
            <a:ext cx="10825141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11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the SGC-UBD253N (catalog number SML-3542, Sigma-Aldrich/Millipore-Sigma, Burlington, MA) is a negative control) probe on SIINFEKL-H2Kb presentation on E.G7-Ova cells (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and effect of SGC-UBD253N on pan HLA-ABC presentation on three different MM cells (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. SGC-UBD253N is a closely related negative control for SGC-UBD253, a chemical probe for the HDAC6 UBD. E.G7-Ova (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and MM cells (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were treated with SGC-UBD253N at indicated concentration for 72h and the relative cell surface of the SIINFEKL-H2Kb complex detected by flow cytometry. Cells were then stained with a monoclonal antibody to SIINFEKL-H2K</a:t>
            </a:r>
            <a:r>
              <a:rPr lang="en-US" sz="1200" baseline="300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nd quantitated using a BD-LSRII sorter interfaced with FlowJo software as above. MMCLs were treated with SGC-UBD253N at the indicated concentrations for 72 h. Cells were then stained with an anti- HLA-ABC (W6/32) antibody</a:t>
            </a:r>
            <a:r>
              <a:rPr lang="en-US" sz="1200" baseline="300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nd quantitated using a BD-LSRII sorter interfaced with FlowJo software as above. Values represent the average of triplicate measurements. Error bars represent the SD. 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8318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200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07:15Z</dcterms:modified>
</cp:coreProperties>
</file>